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797675" cy="987425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948"/>
    <p:restoredTop sz="84535" autoAdjust="0"/>
  </p:normalViewPr>
  <p:slideViewPr>
    <p:cSldViewPr snapToGrid="0">
      <p:cViewPr>
        <p:scale>
          <a:sx n="325" d="100"/>
          <a:sy n="325" d="100"/>
        </p:scale>
        <p:origin x="-2640" y="-80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Users/ericlam/Desktop/Gaby/Copy%20of%20measuremen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806364829396325"/>
          <c:y val="0.0555555555555555"/>
          <c:w val="0.883252405949256"/>
          <c:h val="0.7056787693205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F$75</c:f>
              <c:strCache>
                <c:ptCount val="1"/>
                <c:pt idx="0">
                  <c:v>pCMV5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J$76:$J$81</c:f>
                <c:numCache>
                  <c:formatCode>General</c:formatCode>
                  <c:ptCount val="6"/>
                  <c:pt idx="0">
                    <c:v>10.79438705856461</c:v>
                  </c:pt>
                  <c:pt idx="1">
                    <c:v>5.28063819089475</c:v>
                  </c:pt>
                  <c:pt idx="2">
                    <c:v>2.751256863417918</c:v>
                  </c:pt>
                  <c:pt idx="3">
                    <c:v>2.399268747978647</c:v>
                  </c:pt>
                  <c:pt idx="4">
                    <c:v>0.931710101909115</c:v>
                  </c:pt>
                  <c:pt idx="5">
                    <c:v>0.6250386521451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E$76:$E$81</c:f>
              <c:numCache>
                <c:formatCode>General</c:formatCode>
                <c:ptCount val="6"/>
                <c:pt idx="0">
                  <c:v>0.0</c:v>
                </c:pt>
                <c:pt idx="1">
                  <c:v>0.5</c:v>
                </c:pt>
                <c:pt idx="2">
                  <c:v>1.0</c:v>
                </c:pt>
                <c:pt idx="3">
                  <c:v>3.0</c:v>
                </c:pt>
                <c:pt idx="4">
                  <c:v>5.0</c:v>
                </c:pt>
                <c:pt idx="5">
                  <c:v>10.0</c:v>
                </c:pt>
              </c:numCache>
            </c:numRef>
          </c:cat>
          <c:val>
            <c:numRef>
              <c:f>Sheet2!$F$76:$F$81</c:f>
              <c:numCache>
                <c:formatCode>General</c:formatCode>
                <c:ptCount val="6"/>
                <c:pt idx="0">
                  <c:v>99.999969169117</c:v>
                </c:pt>
                <c:pt idx="1">
                  <c:v>79.10742435411611</c:v>
                </c:pt>
                <c:pt idx="2">
                  <c:v>27.36950227547328</c:v>
                </c:pt>
                <c:pt idx="3">
                  <c:v>13.07229441273488</c:v>
                </c:pt>
                <c:pt idx="4">
                  <c:v>10.83705539168941</c:v>
                </c:pt>
                <c:pt idx="5">
                  <c:v>8.971786967230778</c:v>
                </c:pt>
              </c:numCache>
            </c:numRef>
          </c:val>
        </c:ser>
        <c:ser>
          <c:idx val="1"/>
          <c:order val="1"/>
          <c:tx>
            <c:strRef>
              <c:f>Sheet2!$G$7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K$76:$K$81</c:f>
                <c:numCache>
                  <c:formatCode>General</c:formatCode>
                  <c:ptCount val="6"/>
                  <c:pt idx="0">
                    <c:v>5.762303588975615</c:v>
                  </c:pt>
                  <c:pt idx="1">
                    <c:v>11.92211999576694</c:v>
                  </c:pt>
                  <c:pt idx="2">
                    <c:v>3.234130608346962</c:v>
                  </c:pt>
                  <c:pt idx="3">
                    <c:v>1.204970940096073</c:v>
                  </c:pt>
                  <c:pt idx="4">
                    <c:v>1.319101592128758</c:v>
                  </c:pt>
                  <c:pt idx="5">
                    <c:v>0.9800935994613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E$76:$E$81</c:f>
              <c:numCache>
                <c:formatCode>General</c:formatCode>
                <c:ptCount val="6"/>
                <c:pt idx="0">
                  <c:v>0.0</c:v>
                </c:pt>
                <c:pt idx="1">
                  <c:v>0.5</c:v>
                </c:pt>
                <c:pt idx="2">
                  <c:v>1.0</c:v>
                </c:pt>
                <c:pt idx="3">
                  <c:v>3.0</c:v>
                </c:pt>
                <c:pt idx="4">
                  <c:v>5.0</c:v>
                </c:pt>
                <c:pt idx="5">
                  <c:v>10.0</c:v>
                </c:pt>
              </c:numCache>
            </c:numRef>
          </c:cat>
          <c:val>
            <c:numRef>
              <c:f>Sheet2!$G$76:$G$81</c:f>
              <c:numCache>
                <c:formatCode>General</c:formatCode>
                <c:ptCount val="6"/>
                <c:pt idx="0">
                  <c:v>48.15783932238649</c:v>
                </c:pt>
                <c:pt idx="1">
                  <c:v>28.29657829610659</c:v>
                </c:pt>
                <c:pt idx="2">
                  <c:v>16.85169543650519</c:v>
                </c:pt>
                <c:pt idx="3">
                  <c:v>12.14736792126779</c:v>
                </c:pt>
                <c:pt idx="4">
                  <c:v>11.33034952047186</c:v>
                </c:pt>
                <c:pt idx="5">
                  <c:v>10.28209949680916</c:v>
                </c:pt>
              </c:numCache>
            </c:numRef>
          </c:val>
        </c:ser>
        <c:ser>
          <c:idx val="2"/>
          <c:order val="2"/>
          <c:tx>
            <c:strRef>
              <c:f>Sheet2!$H$75</c:f>
              <c:strCache>
                <c:ptCount val="1"/>
                <c:pt idx="0">
                  <c:v>K527/633R 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L$76:$L$80</c:f>
                <c:numCache>
                  <c:formatCode>General</c:formatCode>
                  <c:ptCount val="5"/>
                  <c:pt idx="0">
                    <c:v>2.901381033893584</c:v>
                  </c:pt>
                  <c:pt idx="1">
                    <c:v>8.50478215761404</c:v>
                  </c:pt>
                  <c:pt idx="2">
                    <c:v>4.135758220015508</c:v>
                  </c:pt>
                  <c:pt idx="3">
                    <c:v>0.240302951473113</c:v>
                  </c:pt>
                  <c:pt idx="4">
                    <c:v>0.5617654244067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E$76:$E$81</c:f>
              <c:numCache>
                <c:formatCode>General</c:formatCode>
                <c:ptCount val="6"/>
                <c:pt idx="0">
                  <c:v>0.0</c:v>
                </c:pt>
                <c:pt idx="1">
                  <c:v>0.5</c:v>
                </c:pt>
                <c:pt idx="2">
                  <c:v>1.0</c:v>
                </c:pt>
                <c:pt idx="3">
                  <c:v>3.0</c:v>
                </c:pt>
                <c:pt idx="4">
                  <c:v>5.0</c:v>
                </c:pt>
                <c:pt idx="5">
                  <c:v>10.0</c:v>
                </c:pt>
              </c:numCache>
            </c:numRef>
          </c:cat>
          <c:val>
            <c:numRef>
              <c:f>Sheet2!$H$76:$H$81</c:f>
              <c:numCache>
                <c:formatCode>General</c:formatCode>
                <c:ptCount val="6"/>
                <c:pt idx="0">
                  <c:v>70.75687659723241</c:v>
                </c:pt>
                <c:pt idx="1">
                  <c:v>69.44656406765406</c:v>
                </c:pt>
                <c:pt idx="2">
                  <c:v>24.4951365823534</c:v>
                </c:pt>
                <c:pt idx="3">
                  <c:v>10.72914730101825</c:v>
                </c:pt>
                <c:pt idx="4">
                  <c:v>10.79080906711606</c:v>
                </c:pt>
                <c:pt idx="5">
                  <c:v>9.218434031622004</c:v>
                </c:pt>
              </c:numCache>
            </c:numRef>
          </c:val>
        </c:ser>
        <c:ser>
          <c:idx val="3"/>
          <c:order val="3"/>
          <c:tx>
            <c:strRef>
              <c:f>Sheet2!$I$75</c:f>
              <c:strCache>
                <c:ptCount val="1"/>
                <c:pt idx="0">
                  <c:v>E529/635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M$76:$M$81</c:f>
                <c:numCache>
                  <c:formatCode>General</c:formatCode>
                  <c:ptCount val="6"/>
                  <c:pt idx="0">
                    <c:v>5.111398719585907</c:v>
                  </c:pt>
                  <c:pt idx="1">
                    <c:v>5.05241536908829</c:v>
                  </c:pt>
                  <c:pt idx="2">
                    <c:v>1.837026544944063</c:v>
                  </c:pt>
                  <c:pt idx="3">
                    <c:v>0.327464763942542</c:v>
                  </c:pt>
                  <c:pt idx="4">
                    <c:v>0.111429226434653</c:v>
                  </c:pt>
                  <c:pt idx="5">
                    <c:v>0.08193419558630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E$76:$E$81</c:f>
              <c:numCache>
                <c:formatCode>General</c:formatCode>
                <c:ptCount val="6"/>
                <c:pt idx="0">
                  <c:v>0.0</c:v>
                </c:pt>
                <c:pt idx="1">
                  <c:v>0.5</c:v>
                </c:pt>
                <c:pt idx="2">
                  <c:v>1.0</c:v>
                </c:pt>
                <c:pt idx="3">
                  <c:v>3.0</c:v>
                </c:pt>
                <c:pt idx="4">
                  <c:v>5.0</c:v>
                </c:pt>
                <c:pt idx="5">
                  <c:v>10.0</c:v>
                </c:pt>
              </c:numCache>
            </c:numRef>
          </c:cat>
          <c:val>
            <c:numRef>
              <c:f>Sheet2!$I$76:$I$81</c:f>
              <c:numCache>
                <c:formatCode>General</c:formatCode>
                <c:ptCount val="6"/>
                <c:pt idx="0">
                  <c:v>71.37349425821051</c:v>
                </c:pt>
                <c:pt idx="1">
                  <c:v>50.66131319213405</c:v>
                </c:pt>
                <c:pt idx="2">
                  <c:v>25.06289006847847</c:v>
                </c:pt>
                <c:pt idx="3">
                  <c:v>9.603820069733291</c:v>
                </c:pt>
                <c:pt idx="4">
                  <c:v>9.264680356195357</c:v>
                </c:pt>
                <c:pt idx="5">
                  <c:v>7.4148273732611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755267664"/>
        <c:axId val="-1755263040"/>
      </c:barChart>
      <c:catAx>
        <c:axId val="-1755267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755263040"/>
        <c:crosses val="autoZero"/>
        <c:auto val="1"/>
        <c:lblAlgn val="ctr"/>
        <c:lblOffset val="100"/>
        <c:noMultiLvlLbl val="0"/>
      </c:catAx>
      <c:valAx>
        <c:axId val="-1755263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75526766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66609142607174"/>
          <c:y val="0.107059638378536"/>
          <c:w val="0.264003937007874"/>
          <c:h val="0.23553295421405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BC0DD9-B081-4915-BF42-DE02D104BDD7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009775" y="741363"/>
            <a:ext cx="2778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1" y="9378823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50444" y="9378823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551C35-5E23-4DF1-BE8B-37DA2C535E3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458796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7551C35-5E23-4DF1-BE8B-37DA2C535E34}" type="slidenum">
              <a:rPr lang="pt-BR" smtClean="0"/>
              <a:t>1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578615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36603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99279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81700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17231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26167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95664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66909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76257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28441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82416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75908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B506F4-3FA8-4ABB-AB59-C5A39D4C3AD8}" type="datetimeFigureOut">
              <a:rPr lang="pt-BR" smtClean="0"/>
              <a:t>23/09/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86504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5.png"/><Relationship Id="rId12" Type="http://schemas.microsoft.com/office/2007/relationships/hdphoto" Target="../media/hdphoto5.wdp"/><Relationship Id="rId13" Type="http://schemas.openxmlformats.org/officeDocument/2006/relationships/image" Target="../media/image6.png"/><Relationship Id="rId14" Type="http://schemas.microsoft.com/office/2007/relationships/hdphoto" Target="../media/hdphoto6.wdp"/><Relationship Id="rId15" Type="http://schemas.openxmlformats.org/officeDocument/2006/relationships/image" Target="../media/image7.png"/><Relationship Id="rId16" Type="http://schemas.microsoft.com/office/2007/relationships/hdphoto" Target="../media/hdphoto7.wdp"/><Relationship Id="rId17" Type="http://schemas.openxmlformats.org/officeDocument/2006/relationships/image" Target="../media/image8.png"/><Relationship Id="rId18" Type="http://schemas.microsoft.com/office/2007/relationships/hdphoto" Target="../media/hdphoto8.wdp"/><Relationship Id="rId19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microsoft.com/office/2007/relationships/hdphoto" Target="../media/hdphoto1.wdp"/><Relationship Id="rId5" Type="http://schemas.openxmlformats.org/officeDocument/2006/relationships/image" Target="../media/image2.png"/><Relationship Id="rId6" Type="http://schemas.microsoft.com/office/2007/relationships/hdphoto" Target="../media/hdphoto2.wdp"/><Relationship Id="rId7" Type="http://schemas.openxmlformats.org/officeDocument/2006/relationships/image" Target="../media/image3.png"/><Relationship Id="rId8" Type="http://schemas.microsoft.com/office/2007/relationships/hdphoto" Target="../media/hdphoto3.wdp"/><Relationship Id="rId9" Type="http://schemas.openxmlformats.org/officeDocument/2006/relationships/image" Target="../media/image4.png"/><Relationship Id="rId10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29"/>
          <p:cNvSpPr txBox="1">
            <a:spLocks noChangeArrowheads="1"/>
          </p:cNvSpPr>
          <p:nvPr/>
        </p:nvSpPr>
        <p:spPr bwMode="auto">
          <a:xfrm>
            <a:off x="1015617" y="1058635"/>
            <a:ext cx="6953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200">
                <a:latin typeface="Arial" charset="0"/>
              </a:rPr>
              <a:t>pCMV5</a:t>
            </a:r>
          </a:p>
        </p:txBody>
      </p:sp>
      <p:sp>
        <p:nvSpPr>
          <p:cNvPr id="6" name="TextBox 30"/>
          <p:cNvSpPr txBox="1">
            <a:spLocks noChangeArrowheads="1"/>
          </p:cNvSpPr>
          <p:nvPr/>
        </p:nvSpPr>
        <p:spPr bwMode="auto">
          <a:xfrm>
            <a:off x="2205718" y="1076049"/>
            <a:ext cx="6905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GB" altLang="en-US" sz="1200">
                <a:latin typeface="Arial" charset="0"/>
              </a:rPr>
              <a:t>FOXK2</a:t>
            </a:r>
          </a:p>
        </p:txBody>
      </p:sp>
      <p:sp>
        <p:nvSpPr>
          <p:cNvPr id="7" name="TextBox 34"/>
          <p:cNvSpPr txBox="1">
            <a:spLocks noChangeArrowheads="1"/>
          </p:cNvSpPr>
          <p:nvPr/>
        </p:nvSpPr>
        <p:spPr bwMode="auto">
          <a:xfrm>
            <a:off x="3182651" y="1076049"/>
            <a:ext cx="9509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GB" altLang="en-US" sz="1200" dirty="0">
                <a:latin typeface="Arial" charset="0"/>
              </a:rPr>
              <a:t>K527/633R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88000"/>
                    </a14:imgEffect>
                    <a14:imgEffect>
                      <a14:brightnessContrast bright="23000" contrast="4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8996" y="1641379"/>
            <a:ext cx="1080000" cy="6970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10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7050" y="1641379"/>
            <a:ext cx="1080000" cy="7038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100000"/>
                    </a14:imgEffect>
                    <a14:imgEffect>
                      <a14:brightnessContrast bright="22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942" y="1641379"/>
            <a:ext cx="1080000" cy="6991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10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5104" y="1641379"/>
            <a:ext cx="1080000" cy="7094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TextBox 34"/>
          <p:cNvSpPr txBox="1">
            <a:spLocks noChangeArrowheads="1"/>
          </p:cNvSpPr>
          <p:nvPr/>
        </p:nvSpPr>
        <p:spPr bwMode="auto">
          <a:xfrm>
            <a:off x="4433661" y="1058635"/>
            <a:ext cx="942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GB" altLang="en-US" sz="1200" smtClean="0">
                <a:latin typeface="Arial" charset="0"/>
              </a:rPr>
              <a:t>E529/635A</a:t>
            </a:r>
            <a:endParaRPr lang="en-GB" altLang="en-US" sz="1200" dirty="0">
              <a:latin typeface="Arial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406787" y="134666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693504" y="13466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.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025172" y="13466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.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406787" y="23547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766827" y="23547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060315" y="235477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246520" y="134666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533237" y="13466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.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864905" y="13466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.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246520" y="23547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606560" y="23547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900048" y="235477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030523" y="134666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317240" y="13466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.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648908" y="13466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.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030523" y="23547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2390563" y="23547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684051" y="235477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878395" y="134666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165112" y="13466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.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496780" y="13466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.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878395" y="23547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238435" y="23547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531923" y="235477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54" name="Picture 53"/>
          <p:cNvPicPr>
            <a:picLocks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10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9997" y="3213568"/>
            <a:ext cx="1080000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Picture 54"/>
          <p:cNvPicPr>
            <a:picLocks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10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0523" y="3213568"/>
            <a:ext cx="1080000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Picture 55"/>
          <p:cNvPicPr>
            <a:picLocks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100000"/>
                    </a14:imgEffect>
                    <a14:imgEffect>
                      <a14:brightnessContrast bright="14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1332" y="3213568"/>
            <a:ext cx="1080000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Picture 56"/>
          <p:cNvPicPr>
            <a:picLocks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100000"/>
                    </a14:imgEffect>
                    <a14:imgEffect>
                      <a14:brightnessContrast bright="17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1848" y="3213568"/>
            <a:ext cx="1080000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8" name="TextBox 29"/>
          <p:cNvSpPr txBox="1">
            <a:spLocks noChangeArrowheads="1"/>
          </p:cNvSpPr>
          <p:nvPr/>
        </p:nvSpPr>
        <p:spPr bwMode="auto">
          <a:xfrm>
            <a:off x="1093200" y="2640826"/>
            <a:ext cx="6953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200">
                <a:latin typeface="Arial" charset="0"/>
              </a:rPr>
              <a:t>pCMV5</a:t>
            </a:r>
          </a:p>
        </p:txBody>
      </p:sp>
      <p:sp>
        <p:nvSpPr>
          <p:cNvPr id="59" name="TextBox 30"/>
          <p:cNvSpPr txBox="1">
            <a:spLocks noChangeArrowheads="1"/>
          </p:cNvSpPr>
          <p:nvPr/>
        </p:nvSpPr>
        <p:spPr bwMode="auto">
          <a:xfrm>
            <a:off x="2283301" y="2658240"/>
            <a:ext cx="6905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GB" altLang="en-US" sz="1200">
                <a:latin typeface="Arial" charset="0"/>
              </a:rPr>
              <a:t>FOXK2</a:t>
            </a:r>
          </a:p>
        </p:txBody>
      </p:sp>
      <p:sp>
        <p:nvSpPr>
          <p:cNvPr id="60" name="TextBox 34"/>
          <p:cNvSpPr txBox="1">
            <a:spLocks noChangeArrowheads="1"/>
          </p:cNvSpPr>
          <p:nvPr/>
        </p:nvSpPr>
        <p:spPr bwMode="auto">
          <a:xfrm>
            <a:off x="3260234" y="2658240"/>
            <a:ext cx="9509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GB" altLang="en-US" sz="1200" dirty="0">
                <a:latin typeface="Arial" charset="0"/>
              </a:rPr>
              <a:t>K527/633R</a:t>
            </a:r>
          </a:p>
        </p:txBody>
      </p:sp>
      <p:sp>
        <p:nvSpPr>
          <p:cNvPr id="61" name="TextBox 34"/>
          <p:cNvSpPr txBox="1">
            <a:spLocks noChangeArrowheads="1"/>
          </p:cNvSpPr>
          <p:nvPr/>
        </p:nvSpPr>
        <p:spPr bwMode="auto">
          <a:xfrm>
            <a:off x="4511244" y="2640826"/>
            <a:ext cx="942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GB" altLang="en-US" sz="1200" smtClean="0">
                <a:latin typeface="Arial" charset="0"/>
              </a:rPr>
              <a:t>E529/635A</a:t>
            </a:r>
            <a:endParaRPr lang="en-GB" altLang="en-US" sz="1200" dirty="0">
              <a:latin typeface="Arial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484370" y="292885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4771087" y="292885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.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5102755" y="292885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.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4484370" y="39369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4844410" y="39369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137898" y="393697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324103" y="292885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3610820" y="292885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.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942488" y="292885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.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324103" y="39369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3684143" y="39369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977631" y="393697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108106" y="292885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394823" y="292885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.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726491" y="292885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.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2108106" y="39369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2468146" y="39369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2761634" y="393697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955978" y="292885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242695" y="292885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0.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574363" y="292885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.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955978" y="39369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1316018" y="39369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5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609506" y="393697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10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87" name="Chart 8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0186266"/>
              </p:ext>
            </p:extLst>
          </p:nvPr>
        </p:nvGraphicFramePr>
        <p:xfrm>
          <a:off x="1089582" y="4591837"/>
          <a:ext cx="4583289" cy="27780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88" name="TextBox 8"/>
          <p:cNvSpPr txBox="1">
            <a:spLocks noChangeArrowheads="1"/>
          </p:cNvSpPr>
          <p:nvPr/>
        </p:nvSpPr>
        <p:spPr bwMode="auto">
          <a:xfrm>
            <a:off x="2793244" y="7136027"/>
            <a:ext cx="1576327" cy="2762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200" dirty="0">
                <a:latin typeface="Arial" charset="0"/>
              </a:rPr>
              <a:t>Paclitaxel (</a:t>
            </a:r>
            <a:r>
              <a:rPr lang="en-GB" altLang="en-US" sz="1200" dirty="0" err="1">
                <a:latin typeface="Arial" charset="0"/>
              </a:rPr>
              <a:t>nM</a:t>
            </a:r>
            <a:r>
              <a:rPr lang="en-GB" altLang="en-US" sz="1200" dirty="0">
                <a:latin typeface="Arial" charset="0"/>
              </a:rPr>
              <a:t>)</a:t>
            </a:r>
          </a:p>
        </p:txBody>
      </p:sp>
      <p:sp>
        <p:nvSpPr>
          <p:cNvPr id="89" name="TextBox 17"/>
          <p:cNvSpPr txBox="1">
            <a:spLocks noChangeArrowheads="1"/>
          </p:cNvSpPr>
          <p:nvPr/>
        </p:nvSpPr>
        <p:spPr bwMode="auto">
          <a:xfrm rot="16200000">
            <a:off x="-26094" y="5500396"/>
            <a:ext cx="19479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GB" altLang="en-US" sz="1200" dirty="0" smtClean="0">
                <a:latin typeface="Arial" charset="0"/>
              </a:rPr>
              <a:t>Relative </a:t>
            </a:r>
            <a:r>
              <a:rPr lang="en-GB" altLang="en-US" sz="1200" dirty="0" err="1" smtClean="0">
                <a:latin typeface="Arial" charset="0"/>
              </a:rPr>
              <a:t>clonogenicity</a:t>
            </a:r>
            <a:r>
              <a:rPr lang="en-GB" altLang="en-US" sz="1200" dirty="0" smtClean="0">
                <a:latin typeface="Arial" charset="0"/>
              </a:rPr>
              <a:t> (%)</a:t>
            </a:r>
            <a:endParaRPr lang="en-GB" altLang="en-US" sz="1200" dirty="0">
              <a:latin typeface="Arial" charset="0"/>
            </a:endParaRPr>
          </a:p>
        </p:txBody>
      </p:sp>
      <p:grpSp>
        <p:nvGrpSpPr>
          <p:cNvPr id="90" name="Group 89"/>
          <p:cNvGrpSpPr/>
          <p:nvPr/>
        </p:nvGrpSpPr>
        <p:grpSpPr>
          <a:xfrm>
            <a:off x="1761374" y="5163428"/>
            <a:ext cx="184589" cy="282633"/>
            <a:chOff x="517160" y="4431553"/>
            <a:chExt cx="184589" cy="282633"/>
          </a:xfrm>
        </p:grpSpPr>
        <p:cxnSp>
          <p:nvCxnSpPr>
            <p:cNvPr id="91" name="Straight Connector 90"/>
            <p:cNvCxnSpPr/>
            <p:nvPr/>
          </p:nvCxnSpPr>
          <p:spPr>
            <a:xfrm flipV="1">
              <a:off x="517160" y="4431553"/>
              <a:ext cx="0" cy="2826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>
              <a:off x="517160" y="4431553"/>
              <a:ext cx="18458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4" name="Straight Connector 93"/>
          <p:cNvCxnSpPr/>
          <p:nvPr/>
        </p:nvCxnSpPr>
        <p:spPr>
          <a:xfrm flipV="1">
            <a:off x="1950992" y="5163428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>
            <a:off x="1858019" y="5343428"/>
            <a:ext cx="1845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6" name="Group 95"/>
          <p:cNvGrpSpPr/>
          <p:nvPr/>
        </p:nvGrpSpPr>
        <p:grpSpPr>
          <a:xfrm>
            <a:off x="2429451" y="5081910"/>
            <a:ext cx="184589" cy="282633"/>
            <a:chOff x="517160" y="4431553"/>
            <a:chExt cx="184589" cy="282633"/>
          </a:xfrm>
        </p:grpSpPr>
        <p:cxnSp>
          <p:nvCxnSpPr>
            <p:cNvPr id="97" name="Straight Connector 96"/>
            <p:cNvCxnSpPr/>
            <p:nvPr/>
          </p:nvCxnSpPr>
          <p:spPr>
            <a:xfrm flipV="1">
              <a:off x="517160" y="4431553"/>
              <a:ext cx="0" cy="2826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/>
            <p:cNvCxnSpPr/>
            <p:nvPr/>
          </p:nvCxnSpPr>
          <p:spPr>
            <a:xfrm>
              <a:off x="517160" y="4431553"/>
              <a:ext cx="18458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9" name="Straight Connector 98"/>
          <p:cNvCxnSpPr/>
          <p:nvPr/>
        </p:nvCxnSpPr>
        <p:spPr>
          <a:xfrm flipV="1">
            <a:off x="2619069" y="5081910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2526096" y="5261910"/>
            <a:ext cx="1845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1" name="Group 100"/>
          <p:cNvGrpSpPr/>
          <p:nvPr/>
        </p:nvGrpSpPr>
        <p:grpSpPr>
          <a:xfrm>
            <a:off x="3102844" y="5920114"/>
            <a:ext cx="184589" cy="282633"/>
            <a:chOff x="517160" y="4431553"/>
            <a:chExt cx="184589" cy="282633"/>
          </a:xfrm>
        </p:grpSpPr>
        <p:cxnSp>
          <p:nvCxnSpPr>
            <p:cNvPr id="102" name="Straight Connector 101"/>
            <p:cNvCxnSpPr/>
            <p:nvPr/>
          </p:nvCxnSpPr>
          <p:spPr>
            <a:xfrm flipV="1">
              <a:off x="517160" y="4431553"/>
              <a:ext cx="0" cy="2826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/>
            <p:cNvCxnSpPr/>
            <p:nvPr/>
          </p:nvCxnSpPr>
          <p:spPr>
            <a:xfrm>
              <a:off x="517160" y="4431553"/>
              <a:ext cx="18458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4" name="Straight Connector 103"/>
          <p:cNvCxnSpPr/>
          <p:nvPr/>
        </p:nvCxnSpPr>
        <p:spPr>
          <a:xfrm flipV="1">
            <a:off x="3292462" y="5920114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>
            <a:off x="3199489" y="6100114"/>
            <a:ext cx="1845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695264" y="4943274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**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2411188" y="4893652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*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3064038" y="5748075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*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08" name="Group 107"/>
          <p:cNvGrpSpPr/>
          <p:nvPr/>
        </p:nvGrpSpPr>
        <p:grpSpPr>
          <a:xfrm>
            <a:off x="3792188" y="6077829"/>
            <a:ext cx="184589" cy="282633"/>
            <a:chOff x="517160" y="4431553"/>
            <a:chExt cx="184589" cy="282633"/>
          </a:xfrm>
        </p:grpSpPr>
        <p:cxnSp>
          <p:nvCxnSpPr>
            <p:cNvPr id="109" name="Straight Connector 108"/>
            <p:cNvCxnSpPr/>
            <p:nvPr/>
          </p:nvCxnSpPr>
          <p:spPr>
            <a:xfrm flipV="1">
              <a:off x="517160" y="4431553"/>
              <a:ext cx="0" cy="2826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>
              <a:off x="517160" y="4431553"/>
              <a:ext cx="18458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1" name="Straight Connector 110"/>
          <p:cNvCxnSpPr/>
          <p:nvPr/>
        </p:nvCxnSpPr>
        <p:spPr>
          <a:xfrm flipV="1">
            <a:off x="3981806" y="6077829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>
            <a:off x="3888833" y="6257829"/>
            <a:ext cx="1845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3699812" y="5842158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 charset="0"/>
                <a:ea typeface="Arial" charset="0"/>
                <a:cs typeface="Arial" charset="0"/>
              </a:rPr>
              <a:t>n.s</a:t>
            </a:r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14" name="Group 113"/>
          <p:cNvGrpSpPr/>
          <p:nvPr/>
        </p:nvGrpSpPr>
        <p:grpSpPr>
          <a:xfrm>
            <a:off x="4460266" y="6107953"/>
            <a:ext cx="184589" cy="282633"/>
            <a:chOff x="517160" y="4431553"/>
            <a:chExt cx="184589" cy="282633"/>
          </a:xfrm>
        </p:grpSpPr>
        <p:cxnSp>
          <p:nvCxnSpPr>
            <p:cNvPr id="115" name="Straight Connector 114"/>
            <p:cNvCxnSpPr/>
            <p:nvPr/>
          </p:nvCxnSpPr>
          <p:spPr>
            <a:xfrm flipV="1">
              <a:off x="517160" y="4431553"/>
              <a:ext cx="0" cy="2826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/>
            <p:cNvCxnSpPr/>
            <p:nvPr/>
          </p:nvCxnSpPr>
          <p:spPr>
            <a:xfrm>
              <a:off x="517160" y="4431553"/>
              <a:ext cx="18458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7" name="Straight Connector 116"/>
          <p:cNvCxnSpPr/>
          <p:nvPr/>
        </p:nvCxnSpPr>
        <p:spPr>
          <a:xfrm flipV="1">
            <a:off x="4649884" y="6107953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/>
          <p:nvPr/>
        </p:nvCxnSpPr>
        <p:spPr>
          <a:xfrm>
            <a:off x="4556911" y="6287953"/>
            <a:ext cx="1845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4367890" y="5872282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 charset="0"/>
                <a:ea typeface="Arial" charset="0"/>
                <a:cs typeface="Arial" charset="0"/>
              </a:rPr>
              <a:t>n.s</a:t>
            </a:r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20" name="Group 119"/>
          <p:cNvGrpSpPr/>
          <p:nvPr/>
        </p:nvGrpSpPr>
        <p:grpSpPr>
          <a:xfrm>
            <a:off x="5128344" y="6138077"/>
            <a:ext cx="184589" cy="282633"/>
            <a:chOff x="517160" y="4431553"/>
            <a:chExt cx="184589" cy="282633"/>
          </a:xfrm>
        </p:grpSpPr>
        <p:cxnSp>
          <p:nvCxnSpPr>
            <p:cNvPr id="121" name="Straight Connector 120"/>
            <p:cNvCxnSpPr/>
            <p:nvPr/>
          </p:nvCxnSpPr>
          <p:spPr>
            <a:xfrm flipV="1">
              <a:off x="517160" y="4431553"/>
              <a:ext cx="0" cy="2826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Connector 121"/>
            <p:cNvCxnSpPr/>
            <p:nvPr/>
          </p:nvCxnSpPr>
          <p:spPr>
            <a:xfrm>
              <a:off x="517160" y="4431553"/>
              <a:ext cx="18458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23" name="Straight Connector 122"/>
          <p:cNvCxnSpPr/>
          <p:nvPr/>
        </p:nvCxnSpPr>
        <p:spPr>
          <a:xfrm flipV="1">
            <a:off x="5317962" y="6138077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/>
          <p:cNvCxnSpPr/>
          <p:nvPr/>
        </p:nvCxnSpPr>
        <p:spPr>
          <a:xfrm>
            <a:off x="5224989" y="6318077"/>
            <a:ext cx="1845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5035968" y="590240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 charset="0"/>
                <a:ea typeface="Arial" charset="0"/>
                <a:cs typeface="Arial" charset="0"/>
              </a:rPr>
              <a:t>n.s</a:t>
            </a:r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6" name="TextBox 9"/>
          <p:cNvSpPr txBox="1">
            <a:spLocks noChangeArrowheads="1"/>
          </p:cNvSpPr>
          <p:nvPr/>
        </p:nvSpPr>
        <p:spPr bwMode="auto">
          <a:xfrm>
            <a:off x="290436" y="688748"/>
            <a:ext cx="3127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GB" altLang="en-US" b="1">
                <a:latin typeface="Arial" charset="0"/>
              </a:rPr>
              <a:t>a</a:t>
            </a:r>
          </a:p>
        </p:txBody>
      </p:sp>
      <p:sp>
        <p:nvSpPr>
          <p:cNvPr id="127" name="TextBox 9"/>
          <p:cNvSpPr txBox="1">
            <a:spLocks noChangeArrowheads="1"/>
          </p:cNvSpPr>
          <p:nvPr/>
        </p:nvSpPr>
        <p:spPr bwMode="auto">
          <a:xfrm>
            <a:off x="290436" y="4086870"/>
            <a:ext cx="3254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GB" altLang="en-US" b="1">
                <a:latin typeface="Arial" charset="0"/>
              </a:rPr>
              <a:t>b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4841104" y="8850926"/>
            <a:ext cx="2095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Nestel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de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Moraes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Figure S1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48630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3</TotalTime>
  <Words>80</Words>
  <Application>Microsoft Macintosh PowerPoint</Application>
  <PresentationFormat>On-screen Show (4:3)</PresentationFormat>
  <Paragraphs>6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Tema do Office</vt:lpstr>
      <vt:lpstr>PowerPoint Presentation</vt:lpstr>
    </vt:vector>
  </TitlesOfParts>
  <Company>INCA</Company>
  <LinksUpToDate>false</LinksUpToDate>
  <SharedDoc>false</SharedDoc>
  <HyperlinksChanged>false</HyperlinksChanged>
  <AppVersion>15.003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Gabriela Nestal de Moraes</dc:creator>
  <cp:lastModifiedBy>Lam, Eric W</cp:lastModifiedBy>
  <cp:revision>74</cp:revision>
  <cp:lastPrinted>2017-01-17T11:28:59Z</cp:lastPrinted>
  <dcterms:created xsi:type="dcterms:W3CDTF">2016-11-04T14:34:04Z</dcterms:created>
  <dcterms:modified xsi:type="dcterms:W3CDTF">2017-09-23T10:59:07Z</dcterms:modified>
</cp:coreProperties>
</file>